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3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4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2" autoAdjust="0"/>
    <p:restoredTop sz="94660"/>
  </p:normalViewPr>
  <p:slideViewPr>
    <p:cSldViewPr snapToGrid="0">
      <p:cViewPr varScale="1">
        <p:scale>
          <a:sx n="61" d="100"/>
          <a:sy n="61" d="100"/>
        </p:scale>
        <p:origin x="215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326158194722698"/>
          <c:y val="9.4177050108642732E-2"/>
          <c:w val="0.63124229293823486"/>
          <c:h val="0.6871239599577011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Calculations!$M$21</c:f>
              <c:strCache>
                <c:ptCount val="1"/>
                <c:pt idx="0">
                  <c:v>Cxcl10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1270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Calculations!$N$22:$N$23</c:f>
                <c:numCache>
                  <c:formatCode>General</c:formatCode>
                  <c:ptCount val="2"/>
                  <c:pt idx="0">
                    <c:v>4.7233857193776145E-2</c:v>
                  </c:pt>
                  <c:pt idx="1">
                    <c:v>0.28900789334516191</c:v>
                  </c:pt>
                </c:numCache>
              </c:numRef>
            </c:plus>
            <c:spPr>
              <a:solidFill>
                <a:schemeClr val="tx1">
                  <a:lumMod val="65000"/>
                  <a:lumOff val="35000"/>
                </a:schemeClr>
              </a:solidFill>
              <a:ln w="12700">
                <a:solidFill>
                  <a:sysClr val="windowText" lastClr="000000"/>
                </a:solidFill>
              </a:ln>
              <a:effectLst/>
            </c:spPr>
          </c:errBars>
          <c:cat>
            <c:strRef>
              <c:f>Calculations!$L$22:$L$23</c:f>
              <c:strCache>
                <c:ptCount val="2"/>
                <c:pt idx="0">
                  <c:v>N.Tu-CN</c:v>
                </c:pt>
                <c:pt idx="1">
                  <c:v>N.Tu-Sk.T6Tg</c:v>
                </c:pt>
              </c:strCache>
            </c:strRef>
          </c:cat>
          <c:val>
            <c:numRef>
              <c:f>Calculations!$M$22:$M$23</c:f>
              <c:numCache>
                <c:formatCode>General</c:formatCode>
                <c:ptCount val="2"/>
                <c:pt idx="0">
                  <c:v>1</c:v>
                </c:pt>
                <c:pt idx="1">
                  <c:v>0.935826702316437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4C0-43F3-9AA6-13C5617220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0"/>
        <c:axId val="370304040"/>
        <c:axId val="1"/>
      </c:barChart>
      <c:catAx>
        <c:axId val="3703040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100" b="0" i="1" dirty="0" smtClean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xcl10</a:t>
                </a:r>
                <a:r>
                  <a:rPr lang="en-US" sz="1100" b="0" dirty="0" smtClean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100" b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RNA </a:t>
                </a:r>
                <a:endParaRPr lang="en-US" sz="1100" b="0" dirty="0" smtClean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defRPr sz="11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100" b="0" dirty="0" smtClean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Fold Change)</a:t>
                </a:r>
                <a:endParaRPr lang="en-US" sz="1100" b="0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defRPr sz="11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 sz="1100" b="0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2.3668639053254437E-2"/>
              <c:y val="0.17232527611125531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none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7030404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2356881950912281"/>
          <c:y val="0.14049921201801038"/>
          <c:w val="0.61238355568248271"/>
          <c:h val="0.697048281547575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K$44</c:f>
              <c:strCache>
                <c:ptCount val="1"/>
                <c:pt idx="0">
                  <c:v>Intensity/mm2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1270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L$45:$L$46</c:f>
                <c:numCache>
                  <c:formatCode>General</c:formatCode>
                  <c:ptCount val="2"/>
                  <c:pt idx="0">
                    <c:v>1268.1030150116203</c:v>
                  </c:pt>
                  <c:pt idx="1">
                    <c:v>120.82761210576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J$45:$J$46</c:f>
              <c:strCache>
                <c:ptCount val="2"/>
                <c:pt idx="0">
                  <c:v>Tu-CN</c:v>
                </c:pt>
                <c:pt idx="1">
                  <c:v>Tu-Sk.T6Tg</c:v>
                </c:pt>
              </c:strCache>
            </c:strRef>
          </c:cat>
          <c:val>
            <c:numRef>
              <c:f>Sheet1!$K$45:$K$46</c:f>
              <c:numCache>
                <c:formatCode>General</c:formatCode>
                <c:ptCount val="2"/>
                <c:pt idx="0">
                  <c:v>17283.627588423558</c:v>
                </c:pt>
                <c:pt idx="1">
                  <c:v>14167.890668411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84E-4211-A46C-AEB86C2B35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0"/>
        <c:axId val="528378352"/>
        <c:axId val="528376384"/>
      </c:barChart>
      <c:catAx>
        <c:axId val="5283783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28376384"/>
        <c:crosses val="autoZero"/>
        <c:auto val="1"/>
        <c:lblAlgn val="ctr"/>
        <c:lblOffset val="100"/>
        <c:noMultiLvlLbl val="0"/>
      </c:catAx>
      <c:valAx>
        <c:axId val="52837638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100" b="0" dirty="0" smtClean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lasma TNF</a:t>
                </a:r>
                <a:r>
                  <a:rPr lang="el-GR" sz="1100" b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1100" b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Intensity/mm</a:t>
                </a:r>
                <a:r>
                  <a:rPr lang="en-US" sz="1100" b="0" baseline="3000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)</a:t>
                </a:r>
              </a:p>
            </c:rich>
          </c:tx>
          <c:layout>
            <c:manualLayout>
              <c:xMode val="edge"/>
              <c:yMode val="edge"/>
              <c:x val="2.0111059178218208E-2"/>
              <c:y val="0.1699650326581777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28378352"/>
        <c:crosses val="autoZero"/>
        <c:crossBetween val="between"/>
        <c:majorUnit val="40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269472440522008"/>
          <c:y val="0.22486750057383681"/>
          <c:w val="0.60441355445094502"/>
          <c:h val="0.6101248558883410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K$54</c:f>
              <c:strCache>
                <c:ptCount val="1"/>
                <c:pt idx="0">
                  <c:v>Int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1270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L$55:$L$56</c:f>
                <c:numCache>
                  <c:formatCode>General</c:formatCode>
                  <c:ptCount val="2"/>
                  <c:pt idx="0">
                    <c:v>64.705480482534767</c:v>
                  </c:pt>
                  <c:pt idx="1">
                    <c:v>349.4479527482520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J$55:$J$56</c:f>
              <c:strCache>
                <c:ptCount val="2"/>
                <c:pt idx="0">
                  <c:v>Tu-CN</c:v>
                </c:pt>
                <c:pt idx="1">
                  <c:v>Tu-Sk.T6Tg</c:v>
                </c:pt>
              </c:strCache>
            </c:strRef>
          </c:cat>
          <c:val>
            <c:numRef>
              <c:f>Sheet1!$K$55:$K$56</c:f>
              <c:numCache>
                <c:formatCode>General</c:formatCode>
                <c:ptCount val="2"/>
                <c:pt idx="0">
                  <c:v>20463.959590502505</c:v>
                </c:pt>
                <c:pt idx="1">
                  <c:v>15325.8389570102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9C6-4C5D-BEF8-2B4AB7529C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0"/>
        <c:axId val="505613128"/>
        <c:axId val="505620016"/>
      </c:barChart>
      <c:catAx>
        <c:axId val="5056131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05620016"/>
        <c:crosses val="autoZero"/>
        <c:auto val="1"/>
        <c:lblAlgn val="ctr"/>
        <c:lblOffset val="100"/>
        <c:noMultiLvlLbl val="0"/>
      </c:catAx>
      <c:valAx>
        <c:axId val="50562001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100" b="0" dirty="0" smtClean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lasma IL-1</a:t>
                </a:r>
                <a:r>
                  <a:rPr lang="el-GR" sz="1100" b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1100" b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Intensity/mm</a:t>
                </a:r>
                <a:r>
                  <a:rPr lang="en-US" sz="1100" b="0" baseline="3000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1100" b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c:rich>
          </c:tx>
          <c:layout>
            <c:manualLayout>
              <c:xMode val="edge"/>
              <c:yMode val="edge"/>
              <c:x val="3.3343888416241603E-3"/>
              <c:y val="0.2196445520661225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056131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9716801397925169"/>
          <c:y val="0.10946074906265406"/>
          <c:w val="0.67134688592880309"/>
          <c:h val="0.7371150646967137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K$48:$K$49</c:f>
              <c:strCache>
                <c:ptCount val="2"/>
                <c:pt idx="0">
                  <c:v>IL16</c:v>
                </c:pt>
                <c:pt idx="1">
                  <c:v>Int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1270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L$50:$L$51</c:f>
                <c:numCache>
                  <c:formatCode>General</c:formatCode>
                  <c:ptCount val="2"/>
                  <c:pt idx="0">
                    <c:v>77.841179527860717</c:v>
                  </c:pt>
                  <c:pt idx="1">
                    <c:v>20.91470197382025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J$50:$J$51</c:f>
              <c:strCache>
                <c:ptCount val="2"/>
                <c:pt idx="0">
                  <c:v>Tu-CN</c:v>
                </c:pt>
                <c:pt idx="1">
                  <c:v>Tu-Sk.T6Tg</c:v>
                </c:pt>
              </c:strCache>
            </c:strRef>
          </c:cat>
          <c:val>
            <c:numRef>
              <c:f>Sheet1!$K$50:$K$51</c:f>
              <c:numCache>
                <c:formatCode>General</c:formatCode>
                <c:ptCount val="2"/>
                <c:pt idx="0">
                  <c:v>17661.190620127476</c:v>
                </c:pt>
                <c:pt idx="1">
                  <c:v>13616.0614235456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D06-4EBB-A8A6-92353A85759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0"/>
        <c:axId val="505599680"/>
        <c:axId val="505600664"/>
      </c:barChart>
      <c:catAx>
        <c:axId val="5055996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05600664"/>
        <c:crosses val="autoZero"/>
        <c:auto val="1"/>
        <c:lblAlgn val="ctr"/>
        <c:lblOffset val="100"/>
        <c:noMultiLvlLbl val="0"/>
      </c:catAx>
      <c:valAx>
        <c:axId val="50560066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100" b="0" dirty="0" smtClean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lasma IL-16 </a:t>
                </a:r>
                <a:r>
                  <a:rPr lang="en-US" sz="1100" b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Intensity/mm</a:t>
                </a:r>
                <a:r>
                  <a:rPr lang="en-US" sz="1100" b="0" baseline="3000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1100" b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c:rich>
          </c:tx>
          <c:layout>
            <c:manualLayout>
              <c:xMode val="edge"/>
              <c:yMode val="edge"/>
              <c:x val="1.6474140929179142E-2"/>
              <c:y val="0.2274057792069759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05599680"/>
        <c:crosses val="autoZero"/>
        <c:crossBetween val="between"/>
        <c:majorUnit val="40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256BE-7A29-4E2A-9900-4879E23861E1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401D4-FEF7-495C-9E06-5AC10FDBF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21715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256BE-7A29-4E2A-9900-4879E23861E1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401D4-FEF7-495C-9E06-5AC10FDBF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41006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256BE-7A29-4E2A-9900-4879E23861E1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401D4-FEF7-495C-9E06-5AC10FDBF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07834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256BE-7A29-4E2A-9900-4879E23861E1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401D4-FEF7-495C-9E06-5AC10FDBF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84179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256BE-7A29-4E2A-9900-4879E23861E1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401D4-FEF7-495C-9E06-5AC10FDBF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98606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256BE-7A29-4E2A-9900-4879E23861E1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401D4-FEF7-495C-9E06-5AC10FDBF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56558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256BE-7A29-4E2A-9900-4879E23861E1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401D4-FEF7-495C-9E06-5AC10FDBF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55937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256BE-7A29-4E2A-9900-4879E23861E1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401D4-FEF7-495C-9E06-5AC10FDBF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35814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256BE-7A29-4E2A-9900-4879E23861E1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401D4-FEF7-495C-9E06-5AC10FDBF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48405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256BE-7A29-4E2A-9900-4879E23861E1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401D4-FEF7-495C-9E06-5AC10FDBF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74878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256BE-7A29-4E2A-9900-4879E23861E1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401D4-FEF7-495C-9E06-5AC10FDBF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58399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2256BE-7A29-4E2A-9900-4879E23861E1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E401D4-FEF7-495C-9E06-5AC10FDBF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67944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84164" y="0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" name="Table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65273971"/>
              </p:ext>
            </p:extLst>
          </p:nvPr>
        </p:nvGraphicFramePr>
        <p:xfrm>
          <a:off x="231362" y="341365"/>
          <a:ext cx="6420731" cy="3020805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208280">
                  <a:extLst>
                    <a:ext uri="{9D8B030D-6E8A-4147-A177-3AD203B41FA5}">
                      <a16:colId xmlns:a16="http://schemas.microsoft.com/office/drawing/2014/main" val="1139652331"/>
                    </a:ext>
                  </a:extLst>
                </a:gridCol>
                <a:gridCol w="562248">
                  <a:extLst>
                    <a:ext uri="{9D8B030D-6E8A-4147-A177-3AD203B41FA5}">
                      <a16:colId xmlns:a16="http://schemas.microsoft.com/office/drawing/2014/main" val="2732798508"/>
                    </a:ext>
                  </a:extLst>
                </a:gridCol>
                <a:gridCol w="540956">
                  <a:extLst>
                    <a:ext uri="{9D8B030D-6E8A-4147-A177-3AD203B41FA5}">
                      <a16:colId xmlns:a16="http://schemas.microsoft.com/office/drawing/2014/main" val="2876014670"/>
                    </a:ext>
                  </a:extLst>
                </a:gridCol>
                <a:gridCol w="509665">
                  <a:extLst>
                    <a:ext uri="{9D8B030D-6E8A-4147-A177-3AD203B41FA5}">
                      <a16:colId xmlns:a16="http://schemas.microsoft.com/office/drawing/2014/main" val="3877990353"/>
                    </a:ext>
                  </a:extLst>
                </a:gridCol>
                <a:gridCol w="524656">
                  <a:extLst>
                    <a:ext uri="{9D8B030D-6E8A-4147-A177-3AD203B41FA5}">
                      <a16:colId xmlns:a16="http://schemas.microsoft.com/office/drawing/2014/main" val="3822109939"/>
                    </a:ext>
                  </a:extLst>
                </a:gridCol>
                <a:gridCol w="464695">
                  <a:extLst>
                    <a:ext uri="{9D8B030D-6E8A-4147-A177-3AD203B41FA5}">
                      <a16:colId xmlns:a16="http://schemas.microsoft.com/office/drawing/2014/main" val="3637882621"/>
                    </a:ext>
                  </a:extLst>
                </a:gridCol>
                <a:gridCol w="524656">
                  <a:extLst>
                    <a:ext uri="{9D8B030D-6E8A-4147-A177-3AD203B41FA5}">
                      <a16:colId xmlns:a16="http://schemas.microsoft.com/office/drawing/2014/main" val="4045911108"/>
                    </a:ext>
                  </a:extLst>
                </a:gridCol>
                <a:gridCol w="554636">
                  <a:extLst>
                    <a:ext uri="{9D8B030D-6E8A-4147-A177-3AD203B41FA5}">
                      <a16:colId xmlns:a16="http://schemas.microsoft.com/office/drawing/2014/main" val="3122058156"/>
                    </a:ext>
                  </a:extLst>
                </a:gridCol>
                <a:gridCol w="509666">
                  <a:extLst>
                    <a:ext uri="{9D8B030D-6E8A-4147-A177-3AD203B41FA5}">
                      <a16:colId xmlns:a16="http://schemas.microsoft.com/office/drawing/2014/main" val="279169362"/>
                    </a:ext>
                  </a:extLst>
                </a:gridCol>
                <a:gridCol w="509665">
                  <a:extLst>
                    <a:ext uri="{9D8B030D-6E8A-4147-A177-3AD203B41FA5}">
                      <a16:colId xmlns:a16="http://schemas.microsoft.com/office/drawing/2014/main" val="1509997681"/>
                    </a:ext>
                  </a:extLst>
                </a:gridCol>
                <a:gridCol w="554636">
                  <a:extLst>
                    <a:ext uri="{9D8B030D-6E8A-4147-A177-3AD203B41FA5}">
                      <a16:colId xmlns:a16="http://schemas.microsoft.com/office/drawing/2014/main" val="3605925562"/>
                    </a:ext>
                  </a:extLst>
                </a:gridCol>
                <a:gridCol w="419671">
                  <a:extLst>
                    <a:ext uri="{9D8B030D-6E8A-4147-A177-3AD203B41FA5}">
                      <a16:colId xmlns:a16="http://schemas.microsoft.com/office/drawing/2014/main" val="1333190939"/>
                    </a:ext>
                  </a:extLst>
                </a:gridCol>
                <a:gridCol w="537301">
                  <a:extLst>
                    <a:ext uri="{9D8B030D-6E8A-4147-A177-3AD203B41FA5}">
                      <a16:colId xmlns:a16="http://schemas.microsoft.com/office/drawing/2014/main" val="705339923"/>
                    </a:ext>
                  </a:extLst>
                </a:gridCol>
              </a:tblGrid>
              <a:tr h="356410">
                <a:tc>
                  <a:txBody>
                    <a:bodyPr/>
                    <a:lstStyle/>
                    <a:p>
                      <a:endParaRPr lang="en-US" sz="1000" dirty="0">
                        <a:solidFill>
                          <a:schemeClr val="tx1">
                            <a:lumMod val="95000"/>
                            <a:lumOff val="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solidFill>
                            <a:schemeClr val="tx1">
                              <a:lumMod val="95000"/>
                              <a:lumOff val="5000"/>
                            </a:schemeClr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2</a:t>
                      </a:r>
                      <a:endParaRPr lang="en-US" sz="1000" dirty="0">
                        <a:solidFill>
                          <a:schemeClr val="tx1">
                            <a:lumMod val="95000"/>
                            <a:lumOff val="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solidFill>
                            <a:schemeClr val="tx1">
                              <a:lumMod val="95000"/>
                              <a:lumOff val="5000"/>
                            </a:schemeClr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,4</a:t>
                      </a:r>
                      <a:endParaRPr lang="en-US" sz="1000" dirty="0">
                        <a:solidFill>
                          <a:schemeClr val="tx1">
                            <a:lumMod val="95000"/>
                            <a:lumOff val="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solidFill>
                            <a:schemeClr val="tx1">
                              <a:lumMod val="95000"/>
                              <a:lumOff val="5000"/>
                            </a:schemeClr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,6</a:t>
                      </a:r>
                      <a:endParaRPr lang="en-US" sz="1000" dirty="0">
                        <a:solidFill>
                          <a:schemeClr val="tx1">
                            <a:lumMod val="95000"/>
                            <a:lumOff val="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solidFill>
                            <a:schemeClr val="tx1">
                              <a:lumMod val="95000"/>
                              <a:lumOff val="5000"/>
                            </a:schemeClr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,8</a:t>
                      </a:r>
                      <a:endParaRPr lang="en-US" sz="1000" dirty="0">
                        <a:solidFill>
                          <a:schemeClr val="tx1">
                            <a:lumMod val="95000"/>
                            <a:lumOff val="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solidFill>
                            <a:schemeClr val="tx1">
                              <a:lumMod val="95000"/>
                              <a:lumOff val="5000"/>
                            </a:schemeClr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,10</a:t>
                      </a:r>
                      <a:endParaRPr lang="en-US" sz="1000" dirty="0">
                        <a:solidFill>
                          <a:schemeClr val="tx1">
                            <a:lumMod val="95000"/>
                            <a:lumOff val="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solidFill>
                            <a:schemeClr val="tx1">
                              <a:lumMod val="95000"/>
                              <a:lumOff val="5000"/>
                            </a:schemeClr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,12</a:t>
                      </a:r>
                      <a:endParaRPr lang="en-US" sz="1000" dirty="0">
                        <a:solidFill>
                          <a:schemeClr val="tx1">
                            <a:lumMod val="95000"/>
                            <a:lumOff val="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solidFill>
                            <a:schemeClr val="tx1">
                              <a:lumMod val="95000"/>
                              <a:lumOff val="5000"/>
                            </a:schemeClr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,14</a:t>
                      </a:r>
                      <a:endParaRPr lang="en-US" sz="1000" dirty="0">
                        <a:solidFill>
                          <a:schemeClr val="tx1">
                            <a:lumMod val="95000"/>
                            <a:lumOff val="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solidFill>
                            <a:schemeClr val="tx1">
                              <a:lumMod val="95000"/>
                              <a:lumOff val="5000"/>
                            </a:schemeClr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,16</a:t>
                      </a:r>
                      <a:endParaRPr lang="en-US" sz="1000" dirty="0">
                        <a:solidFill>
                          <a:schemeClr val="tx1">
                            <a:lumMod val="95000"/>
                            <a:lumOff val="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solidFill>
                            <a:schemeClr val="tx1">
                              <a:lumMod val="95000"/>
                              <a:lumOff val="5000"/>
                            </a:schemeClr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,18</a:t>
                      </a:r>
                      <a:endParaRPr lang="en-US" sz="1000" dirty="0">
                        <a:solidFill>
                          <a:schemeClr val="tx1">
                            <a:lumMod val="95000"/>
                            <a:lumOff val="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solidFill>
                            <a:schemeClr val="tx1">
                              <a:lumMod val="95000"/>
                              <a:lumOff val="5000"/>
                            </a:schemeClr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,20</a:t>
                      </a:r>
                      <a:endParaRPr lang="en-US" sz="1000" dirty="0">
                        <a:solidFill>
                          <a:schemeClr val="tx1">
                            <a:lumMod val="95000"/>
                            <a:lumOff val="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solidFill>
                            <a:schemeClr val="tx1">
                              <a:lumMod val="95000"/>
                              <a:lumOff val="5000"/>
                            </a:schemeClr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,22</a:t>
                      </a:r>
                      <a:endParaRPr lang="en-US" sz="1000" dirty="0">
                        <a:solidFill>
                          <a:schemeClr val="tx1">
                            <a:lumMod val="95000"/>
                            <a:lumOff val="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solidFill>
                            <a:schemeClr val="tx1">
                              <a:lumMod val="95000"/>
                              <a:lumOff val="5000"/>
                            </a:schemeClr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,24</a:t>
                      </a:r>
                      <a:endParaRPr lang="en-US" sz="1000" dirty="0">
                        <a:solidFill>
                          <a:schemeClr val="tx1">
                            <a:lumMod val="95000"/>
                            <a:lumOff val="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35374427"/>
                  </a:ext>
                </a:extLst>
              </a:tr>
              <a:tr h="433473"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 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79384536"/>
                  </a:ext>
                </a:extLst>
              </a:tr>
              <a:tr h="433473"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13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5a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-CSF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-CSF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L-1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L-11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CAM-1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N-</a:t>
                      </a:r>
                      <a:r>
                        <a:rPr lang="el-GR" sz="10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γ</a:t>
                      </a:r>
                      <a:endParaRPr lang="en-US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 smtClean="0">
                          <a:solidFill>
                            <a:srgbClr val="7030A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</a:t>
                      </a:r>
                      <a:r>
                        <a:rPr lang="el-GR" sz="1000" b="1" dirty="0" smtClean="0">
                          <a:solidFill>
                            <a:srgbClr val="7030A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endParaRPr lang="en-US" sz="1000" b="1" dirty="0">
                        <a:solidFill>
                          <a:srgbClr val="7030A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</a:t>
                      </a:r>
                      <a:r>
                        <a:rPr lang="el-GR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1ra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2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8737505"/>
                  </a:ext>
                </a:extLst>
              </a:tr>
              <a:tr h="433473"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3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4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5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6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7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0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3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12p70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 smtClean="0">
                          <a:solidFill>
                            <a:srgbClr val="00B05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6</a:t>
                      </a:r>
                      <a:endParaRPr lang="en-US" sz="1000" b="1" dirty="0">
                        <a:solidFill>
                          <a:srgbClr val="00B05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7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23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27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75402924"/>
                  </a:ext>
                </a:extLst>
              </a:tr>
              <a:tr h="433473"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rgbClr val="C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10</a:t>
                      </a:r>
                      <a:endParaRPr lang="en-US" sz="1200" b="1" dirty="0">
                        <a:solidFill>
                          <a:srgbClr val="C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11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1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-CSF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L2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L12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9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L3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L4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2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L5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-12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239465"/>
                  </a:ext>
                </a:extLst>
              </a:tr>
              <a:tr h="433473"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L17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P1</a:t>
                      </a:r>
                      <a:endParaRPr 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 smtClean="0">
                          <a:solidFill>
                            <a:srgbClr val="0070C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-</a:t>
                      </a:r>
                      <a:r>
                        <a:rPr lang="el-GR" sz="1000" b="1" dirty="0" smtClean="0">
                          <a:solidFill>
                            <a:srgbClr val="0070C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endParaRPr lang="en-US" sz="1000" b="1" dirty="0">
                        <a:solidFill>
                          <a:srgbClr val="0070C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m-1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33591869"/>
                  </a:ext>
                </a:extLst>
              </a:tr>
              <a:tr h="433473"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S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19751"/>
                  </a:ext>
                </a:extLst>
              </a:tr>
            </a:tbl>
          </a:graphicData>
        </a:graphic>
      </p:graphicFrame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66610310"/>
              </p:ext>
            </p:extLst>
          </p:nvPr>
        </p:nvGraphicFramePr>
        <p:xfrm>
          <a:off x="3432643" y="6415258"/>
          <a:ext cx="3219450" cy="18648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20" name="Group 19"/>
          <p:cNvGrpSpPr/>
          <p:nvPr/>
        </p:nvGrpSpPr>
        <p:grpSpPr>
          <a:xfrm>
            <a:off x="4932831" y="6683231"/>
            <a:ext cx="666750" cy="246221"/>
            <a:chOff x="4932831" y="6683231"/>
            <a:chExt cx="666750" cy="246221"/>
          </a:xfrm>
        </p:grpSpPr>
        <p:cxnSp>
          <p:nvCxnSpPr>
            <p:cNvPr id="15" name="Straight Connector 14"/>
            <p:cNvCxnSpPr/>
            <p:nvPr/>
          </p:nvCxnSpPr>
          <p:spPr>
            <a:xfrm>
              <a:off x="4932831" y="6888406"/>
              <a:ext cx="6667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/>
            <p:cNvSpPr txBox="1"/>
            <p:nvPr/>
          </p:nvSpPr>
          <p:spPr>
            <a:xfrm>
              <a:off x="5084906" y="6683231"/>
              <a:ext cx="3626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23" name="Chart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7718291"/>
              </p:ext>
            </p:extLst>
          </p:nvPr>
        </p:nvGraphicFramePr>
        <p:xfrm>
          <a:off x="111971" y="3809656"/>
          <a:ext cx="2993179" cy="18946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19" name="Group 18"/>
          <p:cNvGrpSpPr/>
          <p:nvPr/>
        </p:nvGrpSpPr>
        <p:grpSpPr>
          <a:xfrm>
            <a:off x="1699666" y="4007717"/>
            <a:ext cx="713323" cy="276999"/>
            <a:chOff x="1699666" y="4007717"/>
            <a:chExt cx="713323" cy="276999"/>
          </a:xfrm>
        </p:grpSpPr>
        <p:cxnSp>
          <p:nvCxnSpPr>
            <p:cNvPr id="25" name="Straight Connector 24"/>
            <p:cNvCxnSpPr/>
            <p:nvPr/>
          </p:nvCxnSpPr>
          <p:spPr>
            <a:xfrm>
              <a:off x="1699666" y="4198140"/>
              <a:ext cx="71332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/>
            <p:cNvSpPr txBox="1"/>
            <p:nvPr/>
          </p:nvSpPr>
          <p:spPr>
            <a:xfrm>
              <a:off x="1934338" y="4007717"/>
              <a:ext cx="2439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28" name="Chart 2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00811961"/>
              </p:ext>
            </p:extLst>
          </p:nvPr>
        </p:nvGraphicFramePr>
        <p:xfrm>
          <a:off x="3288375" y="3591502"/>
          <a:ext cx="3407521" cy="19343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17" name="Group 16"/>
          <p:cNvGrpSpPr/>
          <p:nvPr/>
        </p:nvGrpSpPr>
        <p:grpSpPr>
          <a:xfrm>
            <a:off x="4902841" y="3959152"/>
            <a:ext cx="713323" cy="276999"/>
            <a:chOff x="4902841" y="3959152"/>
            <a:chExt cx="713323" cy="276999"/>
          </a:xfrm>
        </p:grpSpPr>
        <p:cxnSp>
          <p:nvCxnSpPr>
            <p:cNvPr id="30" name="Straight Connector 29"/>
            <p:cNvCxnSpPr/>
            <p:nvPr/>
          </p:nvCxnSpPr>
          <p:spPr>
            <a:xfrm>
              <a:off x="4902841" y="4149575"/>
              <a:ext cx="71332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/>
            <p:cNvSpPr txBox="1"/>
            <p:nvPr/>
          </p:nvSpPr>
          <p:spPr>
            <a:xfrm>
              <a:off x="5137513" y="3959152"/>
              <a:ext cx="2439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3" name="TextBox 32"/>
          <p:cNvSpPr txBox="1"/>
          <p:nvPr/>
        </p:nvSpPr>
        <p:spPr>
          <a:xfrm>
            <a:off x="3086716" y="8715375"/>
            <a:ext cx="8867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2" name="Chart 3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61125116"/>
              </p:ext>
            </p:extLst>
          </p:nvPr>
        </p:nvGraphicFramePr>
        <p:xfrm>
          <a:off x="157925" y="6069056"/>
          <a:ext cx="2947225" cy="22110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pSp>
        <p:nvGrpSpPr>
          <p:cNvPr id="12" name="Group 11"/>
          <p:cNvGrpSpPr/>
          <p:nvPr/>
        </p:nvGrpSpPr>
        <p:grpSpPr>
          <a:xfrm>
            <a:off x="1760460" y="6206337"/>
            <a:ext cx="591733" cy="251013"/>
            <a:chOff x="1760460" y="6206337"/>
            <a:chExt cx="591733" cy="251013"/>
          </a:xfrm>
        </p:grpSpPr>
        <p:cxnSp>
          <p:nvCxnSpPr>
            <p:cNvPr id="36" name="Straight Connector 35"/>
            <p:cNvCxnSpPr/>
            <p:nvPr/>
          </p:nvCxnSpPr>
          <p:spPr>
            <a:xfrm>
              <a:off x="1760460" y="6415258"/>
              <a:ext cx="59173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/>
            <p:cNvSpPr txBox="1"/>
            <p:nvPr/>
          </p:nvSpPr>
          <p:spPr>
            <a:xfrm>
              <a:off x="1955130" y="6206337"/>
              <a:ext cx="202391" cy="2510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1" name="TextBox 40"/>
          <p:cNvSpPr txBox="1"/>
          <p:nvPr/>
        </p:nvSpPr>
        <p:spPr>
          <a:xfrm>
            <a:off x="161742" y="3487121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441727" y="3505149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165749" y="5807446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3441727" y="5830334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.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09263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9</TotalTime>
  <Words>105</Words>
  <Application>Microsoft Office PowerPoint</Application>
  <PresentationFormat>Letter Paper (8.5x11 in)</PresentationFormat>
  <Paragraphs>7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The University of Chicag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mant, Sadhana [BSD] - SUR</dc:creator>
  <cp:lastModifiedBy>Samant, Sadhana [BSD] - SUR</cp:lastModifiedBy>
  <cp:revision>15</cp:revision>
  <dcterms:created xsi:type="dcterms:W3CDTF">2020-07-23T14:53:31Z</dcterms:created>
  <dcterms:modified xsi:type="dcterms:W3CDTF">2020-08-13T15:46:53Z</dcterms:modified>
</cp:coreProperties>
</file>